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5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6" autoAdjust="0"/>
    <p:restoredTop sz="94660"/>
  </p:normalViewPr>
  <p:slideViewPr>
    <p:cSldViewPr snapToGrid="0">
      <p:cViewPr varScale="1">
        <p:scale>
          <a:sx n="81" d="100"/>
          <a:sy n="81" d="100"/>
        </p:scale>
        <p:origin x="120" y="7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2C0ADD6-A20D-45A7-B50E-CE209C45B2A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38043698-C118-4356-979B-6BA4086CD6C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AC9E00E9-C512-4453-9D02-73130E0296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9E524-4E0F-428D-89F7-A2287CE58E15}" type="datetimeFigureOut">
              <a:rPr lang="en-US" smtClean="0"/>
              <a:t>9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3D1E1B65-4791-4CCD-8C35-6F049F6A58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F631962-DCFD-4685-9D9F-B9454616EF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D00D9-A9EF-4585-A823-15D5349AFD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4874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5F95F3E-D3E5-4E80-930B-F7B58D17E8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7ED08EC4-452B-41DD-ABB4-EACFE88CCAF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CCAC56A1-3314-4E3C-A6B2-377356BAB3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9E524-4E0F-428D-89F7-A2287CE58E15}" type="datetimeFigureOut">
              <a:rPr lang="en-US" smtClean="0"/>
              <a:t>9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61EF4F32-EEF7-4AE0-AB99-A01D5D6227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156AD93C-2764-4C29-AC8C-77932DCE33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D00D9-A9EF-4585-A823-15D5349AFD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67349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2C811BAE-B2AF-4213-BC41-926E5CBE8EE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E220C558-76B3-4E7A-9C04-31E5CFF50A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66369035-A5E1-481A-AEEA-31347FD9E2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9E524-4E0F-428D-89F7-A2287CE58E15}" type="datetimeFigureOut">
              <a:rPr lang="en-US" smtClean="0"/>
              <a:t>9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78431997-2AB4-4971-B460-92DC41755E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5FE3918-131B-45A6-90D5-68CF87EA0F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D00D9-A9EF-4585-A823-15D5349AFD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75665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C702CD0-66B7-4AEC-994B-722FAC172A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73EAF748-2654-439C-8A7B-6046FEB6C7D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257C9608-F823-4753-9D45-4642B8DB00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9E524-4E0F-428D-89F7-A2287CE58E15}" type="datetimeFigureOut">
              <a:rPr lang="en-US" smtClean="0"/>
              <a:t>9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FEFAE6A5-9AC4-4CE3-82A2-FEBD445D81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5322127D-73C3-4054-A828-600670DB1A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D00D9-A9EF-4585-A823-15D5349AFD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56116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D96D465-852B-43A1-8C67-B9BEFE178A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7446180F-76AB-4539-BFC4-85B2CD93FAC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E4058F11-F99A-4B42-A718-34D858505C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9E524-4E0F-428D-89F7-A2287CE58E15}" type="datetimeFigureOut">
              <a:rPr lang="en-US" smtClean="0"/>
              <a:t>9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93F10BA8-5B89-4029-8ED6-A264D4EAC6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D6B4276D-89D4-4CE9-91C8-9C93E6EC6B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D00D9-A9EF-4585-A823-15D5349AFD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58936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3DE9495-AFD6-4C4D-BA46-CA4BF08428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2B1DC45C-EF55-4C62-AC25-8E073D65126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4418EFF4-33C0-483E-956C-DBF07CB8B93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0BF2208F-C480-4C5A-91BE-26F42019D4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9E524-4E0F-428D-89F7-A2287CE58E15}" type="datetimeFigureOut">
              <a:rPr lang="en-US" smtClean="0"/>
              <a:t>9/2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AF58A6C3-0569-4353-B137-758B4B2E8D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6407D1AE-D730-4173-B084-0B11DA1A47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D00D9-A9EF-4585-A823-15D5349AFD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79818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EEE3321-0F27-4E2F-93F4-F879769C50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D664CD60-2DBC-4D44-B098-557D13A8F5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9A2EDC9F-ADBC-4951-B75C-A1D0A9261D7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8FC871BA-AEEA-431C-B44C-FFB2A6FEDA1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34C1B02D-B16A-4D82-A134-0DF27DDCBC9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1C88BB02-3D9B-499E-8789-9BFDCA794A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9E524-4E0F-428D-89F7-A2287CE58E15}" type="datetimeFigureOut">
              <a:rPr lang="en-US" smtClean="0"/>
              <a:t>9/22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C168389F-5489-4C2E-A2DC-7DAB6ABEAF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FBB0E76D-2B06-43FC-8F3E-103D0F6034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D00D9-A9EF-4585-A823-15D5349AFD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24844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5210A45-0EF6-4A59-B696-6E40567407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658BC2F2-4B08-4063-89BC-6AAC5C0F75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9E524-4E0F-428D-89F7-A2287CE58E15}" type="datetimeFigureOut">
              <a:rPr lang="en-US" smtClean="0"/>
              <a:t>9/22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52B2673C-73CB-4760-A19A-41FE1654AE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74C73E2A-E4E4-4A54-A2BE-C9B14459FE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D00D9-A9EF-4585-A823-15D5349AFD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62382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A609E24A-4E3A-4ED6-A1BE-579654BBC8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9E524-4E0F-428D-89F7-A2287CE58E15}" type="datetimeFigureOut">
              <a:rPr lang="en-US" smtClean="0"/>
              <a:t>9/22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0EEABD05-067F-42EA-8DBC-9605B6B7FF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06BA0EB5-8BC3-426C-91F0-5909E24234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D00D9-A9EF-4585-A823-15D5349AFD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26069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EA5E5AE-3EEB-41C2-BA37-52A187D194C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6CD23234-ED6B-4AF5-84B0-67F26FEBF67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6007ECCC-B7F3-423E-AEBE-788316DBCDC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045553F3-2C39-4018-89CA-2F8A644AEF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9E524-4E0F-428D-89F7-A2287CE58E15}" type="datetimeFigureOut">
              <a:rPr lang="en-US" smtClean="0"/>
              <a:t>9/2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207A7E6D-7D9A-4DAD-8965-5B16DC1B12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259B7880-DEB8-4BE2-A981-BCF5B1A415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D00D9-A9EF-4585-A823-15D5349AFD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9184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757E7E4B-70C7-494D-B018-CBA294F70B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D835DEB3-4240-4215-937D-124074DDFA1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147E71C1-ADDF-41B1-949B-DAD212181F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2C0B281C-1756-49EF-B853-BF13651624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29E524-4E0F-428D-89F7-A2287CE58E15}" type="datetimeFigureOut">
              <a:rPr lang="en-US" smtClean="0"/>
              <a:t>9/22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4D554CBE-4A4D-4EA5-A2B3-28C8481D9E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1EDFE43D-F193-4D9A-8624-B8FBC32B1E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3D00D9-A9EF-4585-A823-15D5349AFD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35849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97883EE4-17B0-4A00-B6CF-64F93623F7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051F73F2-9EF4-46E2-A0A9-9FAE68E87A4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C10C5703-FFCE-4E4D-87F2-0007A7BA627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29E524-4E0F-428D-89F7-A2287CE58E15}" type="datetimeFigureOut">
              <a:rPr lang="en-US" smtClean="0"/>
              <a:t>9/22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C5E53683-DF3D-4D3A-A5D3-1C2C790B062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5382730E-ECA2-4099-B058-03C4312E05B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3D00D9-A9EF-4585-A823-15D5349AFD9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06480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C0BD01FC-ED8E-8626-0174-6150F87BF09A}"/>
              </a:ext>
            </a:extLst>
          </p:cNvPr>
          <p:cNvSpPr txBox="1"/>
          <p:nvPr/>
        </p:nvSpPr>
        <p:spPr>
          <a:xfrm>
            <a:off x="9391865" y="6581001"/>
            <a:ext cx="28001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enick et al., Supplemental Figure 1</a:t>
            </a:r>
          </a:p>
        </p:txBody>
      </p:sp>
      <p:sp>
        <p:nvSpPr>
          <p:cNvPr id="11" name="Callout: Right Arrow 10">
            <a:extLst>
              <a:ext uri="{FF2B5EF4-FFF2-40B4-BE49-F238E27FC236}">
                <a16:creationId xmlns:a16="http://schemas.microsoft.com/office/drawing/2014/main" xmlns="" id="{B9284221-0D92-FDC5-153E-AC292F765A22}"/>
              </a:ext>
            </a:extLst>
          </p:cNvPr>
          <p:cNvSpPr/>
          <p:nvPr/>
        </p:nvSpPr>
        <p:spPr>
          <a:xfrm>
            <a:off x="3727461" y="1089985"/>
            <a:ext cx="1975686" cy="768896"/>
          </a:xfrm>
          <a:prstGeom prst="rightArrowCallout">
            <a:avLst>
              <a:gd name="adj1" fmla="val 25000"/>
              <a:gd name="adj2" fmla="val 25000"/>
              <a:gd name="adj3" fmla="val 25000"/>
              <a:gd name="adj4" fmla="val 72519"/>
            </a:avLst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omen with Suspected Ovarian Cancer</a:t>
            </a:r>
          </a:p>
        </p:txBody>
      </p:sp>
      <p:sp>
        <p:nvSpPr>
          <p:cNvPr id="13" name="Callout: Down Arrow 12">
            <a:extLst>
              <a:ext uri="{FF2B5EF4-FFF2-40B4-BE49-F238E27FC236}">
                <a16:creationId xmlns:a16="http://schemas.microsoft.com/office/drawing/2014/main" xmlns="" id="{94F9617E-D06A-77EB-36CC-DB9B45D93B21}"/>
              </a:ext>
            </a:extLst>
          </p:cNvPr>
          <p:cNvSpPr/>
          <p:nvPr/>
        </p:nvSpPr>
        <p:spPr>
          <a:xfrm>
            <a:off x="6198577" y="1089985"/>
            <a:ext cx="1438633" cy="1252990"/>
          </a:xfrm>
          <a:prstGeom prst="downArrowCallout">
            <a:avLst>
              <a:gd name="adj1" fmla="val 18561"/>
              <a:gd name="adj2" fmla="val 18521"/>
              <a:gd name="adj3" fmla="val 25541"/>
              <a:gd name="adj4" fmla="val 64977"/>
            </a:avLst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agnostic Surgery: Assess for R0 Feasibility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xmlns="" id="{38A995C9-5CEC-B17D-4DCA-0944661BDD2C}"/>
              </a:ext>
            </a:extLst>
          </p:cNvPr>
          <p:cNvSpPr/>
          <p:nvPr/>
        </p:nvSpPr>
        <p:spPr>
          <a:xfrm>
            <a:off x="3720824" y="2207165"/>
            <a:ext cx="1451907" cy="76889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0 Feasible: Primary Debulking Surgery (PDS)</a:t>
            </a:r>
          </a:p>
        </p:txBody>
      </p:sp>
      <p:sp>
        <p:nvSpPr>
          <p:cNvPr id="15" name="Callout: Down Arrow 14">
            <a:extLst>
              <a:ext uri="{FF2B5EF4-FFF2-40B4-BE49-F238E27FC236}">
                <a16:creationId xmlns:a16="http://schemas.microsoft.com/office/drawing/2014/main" xmlns="" id="{106B27FA-6DEF-B1AD-DA59-E73AF1591AD3}"/>
              </a:ext>
            </a:extLst>
          </p:cNvPr>
          <p:cNvSpPr/>
          <p:nvPr/>
        </p:nvSpPr>
        <p:spPr>
          <a:xfrm>
            <a:off x="3727461" y="3059003"/>
            <a:ext cx="1438633" cy="1185272"/>
          </a:xfrm>
          <a:prstGeom prst="downArrowCallout">
            <a:avLst>
              <a:gd name="adj1" fmla="val 18561"/>
              <a:gd name="adj2" fmla="val 15927"/>
              <a:gd name="adj3" fmla="val 25000"/>
              <a:gd name="adj4" fmla="val 64977"/>
            </a:avLst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0 Not Feasible: Neoadjuvant Chemotherapy (NACT)</a:t>
            </a:r>
          </a:p>
        </p:txBody>
      </p:sp>
      <p:sp>
        <p:nvSpPr>
          <p:cNvPr id="18" name="Arrow: Down 17">
            <a:extLst>
              <a:ext uri="{FF2B5EF4-FFF2-40B4-BE49-F238E27FC236}">
                <a16:creationId xmlns:a16="http://schemas.microsoft.com/office/drawing/2014/main" xmlns="" id="{FE17C14A-C010-2FF3-80F3-E4C07A7D439C}"/>
              </a:ext>
            </a:extLst>
          </p:cNvPr>
          <p:cNvSpPr/>
          <p:nvPr/>
        </p:nvSpPr>
        <p:spPr>
          <a:xfrm rot="5400000">
            <a:off x="5364402" y="3182059"/>
            <a:ext cx="336177" cy="635368"/>
          </a:xfrm>
          <a:prstGeom prst="down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Arrow: Down 18">
            <a:extLst>
              <a:ext uri="{FF2B5EF4-FFF2-40B4-BE49-F238E27FC236}">
                <a16:creationId xmlns:a16="http://schemas.microsoft.com/office/drawing/2014/main" xmlns="" id="{C6653A43-527F-589D-17D9-3A0A35E03761}"/>
              </a:ext>
            </a:extLst>
          </p:cNvPr>
          <p:cNvSpPr/>
          <p:nvPr/>
        </p:nvSpPr>
        <p:spPr>
          <a:xfrm rot="5400000">
            <a:off x="5364402" y="2244561"/>
            <a:ext cx="336177" cy="635368"/>
          </a:xfrm>
          <a:prstGeom prst="down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Arrow: Down 22">
            <a:extLst>
              <a:ext uri="{FF2B5EF4-FFF2-40B4-BE49-F238E27FC236}">
                <a16:creationId xmlns:a16="http://schemas.microsoft.com/office/drawing/2014/main" xmlns="" id="{9CF26A3D-BC62-BC9E-D771-B7A28F0E9826}"/>
              </a:ext>
            </a:extLst>
          </p:cNvPr>
          <p:cNvSpPr/>
          <p:nvPr/>
        </p:nvSpPr>
        <p:spPr>
          <a:xfrm rot="16200000" flipH="1">
            <a:off x="8138135" y="2845292"/>
            <a:ext cx="201707" cy="326930"/>
          </a:xfrm>
          <a:prstGeom prst="down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xmlns="" id="{BD7E1928-EF92-59BA-733B-F2B1EC72CA62}"/>
              </a:ext>
            </a:extLst>
          </p:cNvPr>
          <p:cNvSpPr/>
          <p:nvPr/>
        </p:nvSpPr>
        <p:spPr>
          <a:xfrm>
            <a:off x="3801949" y="4377402"/>
            <a:ext cx="1310114" cy="73265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terval Debulking Surgery (IDS)</a:t>
            </a:r>
          </a:p>
        </p:txBody>
      </p:sp>
      <p:sp>
        <p:nvSpPr>
          <p:cNvPr id="25" name="Arrow: Down 24">
            <a:extLst>
              <a:ext uri="{FF2B5EF4-FFF2-40B4-BE49-F238E27FC236}">
                <a16:creationId xmlns:a16="http://schemas.microsoft.com/office/drawing/2014/main" xmlns="" id="{B79647C8-0FAB-5D9B-CA77-DFF5AF17BDB0}"/>
              </a:ext>
            </a:extLst>
          </p:cNvPr>
          <p:cNvSpPr/>
          <p:nvPr/>
        </p:nvSpPr>
        <p:spPr>
          <a:xfrm flipH="1">
            <a:off x="4349988" y="5267730"/>
            <a:ext cx="214034" cy="391939"/>
          </a:xfrm>
          <a:prstGeom prst="downArrow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xmlns="" id="{59DC87B3-B64C-D522-2F69-0B2679DA33B9}"/>
              </a:ext>
            </a:extLst>
          </p:cNvPr>
          <p:cNvSpPr/>
          <p:nvPr/>
        </p:nvSpPr>
        <p:spPr>
          <a:xfrm>
            <a:off x="3446123" y="5813785"/>
            <a:ext cx="2021763" cy="55992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5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earch Specimen</a:t>
            </a:r>
          </a:p>
          <a:p>
            <a:pPr algn="ctr"/>
            <a:r>
              <a:rPr lang="en-US" sz="15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“post-NACT”)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xmlns="" id="{6A0E7063-0D24-7912-4179-41AC9E3CF8AB}"/>
              </a:ext>
            </a:extLst>
          </p:cNvPr>
          <p:cNvSpPr/>
          <p:nvPr/>
        </p:nvSpPr>
        <p:spPr>
          <a:xfrm>
            <a:off x="8444529" y="2677485"/>
            <a:ext cx="1771202" cy="65416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5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esearch Biopsy</a:t>
            </a:r>
          </a:p>
          <a:p>
            <a:pPr algn="ctr"/>
            <a:r>
              <a:rPr lang="en-US" sz="15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“pre-NACT”)</a:t>
            </a:r>
          </a:p>
        </p:txBody>
      </p:sp>
      <p:pic>
        <p:nvPicPr>
          <p:cNvPr id="28" name="Picture 27">
            <a:extLst>
              <a:ext uri="{FF2B5EF4-FFF2-40B4-BE49-F238E27FC236}">
                <a16:creationId xmlns:a16="http://schemas.microsoft.com/office/drawing/2014/main" xmlns="" id="{13FC205B-11FB-B00B-6422-82CF7B3C9AB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92250" y="2391102"/>
            <a:ext cx="2141198" cy="13410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709571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 descr="A close up of a map&#10;&#10;Description automatically generated">
            <a:extLst>
              <a:ext uri="{FF2B5EF4-FFF2-40B4-BE49-F238E27FC236}">
                <a16:creationId xmlns:a16="http://schemas.microsoft.com/office/drawing/2014/main" xmlns="" id="{9B59969E-446E-43A6-8070-B82893CD13E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0310"/>
          <a:stretch/>
        </p:blipFill>
        <p:spPr>
          <a:xfrm>
            <a:off x="4423385" y="2227314"/>
            <a:ext cx="3477865" cy="2889362"/>
          </a:xfrm>
          <a:prstGeom prst="rect">
            <a:avLst/>
          </a:prstGeom>
          <a:ln>
            <a:noFill/>
          </a:ln>
        </p:spPr>
      </p:pic>
      <p:pic>
        <p:nvPicPr>
          <p:cNvPr id="12" name="Picture 11" descr="A close up of a map&#10;&#10;Description automatically generated">
            <a:extLst>
              <a:ext uri="{FF2B5EF4-FFF2-40B4-BE49-F238E27FC236}">
                <a16:creationId xmlns:a16="http://schemas.microsoft.com/office/drawing/2014/main" xmlns="" id="{F1E80A0C-C453-4F71-827B-2EE79FBFCBD9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68" t="10310"/>
          <a:stretch/>
        </p:blipFill>
        <p:spPr>
          <a:xfrm>
            <a:off x="1013028" y="2270736"/>
            <a:ext cx="3350290" cy="2889362"/>
          </a:xfrm>
          <a:prstGeom prst="rect">
            <a:avLst/>
          </a:prstGeom>
          <a:ln>
            <a:noFill/>
          </a:ln>
        </p:spPr>
      </p:pic>
      <p:pic>
        <p:nvPicPr>
          <p:cNvPr id="16" name="Picture 15" descr="A close up of a map&#10;&#10;Description automatically generated">
            <a:extLst>
              <a:ext uri="{FF2B5EF4-FFF2-40B4-BE49-F238E27FC236}">
                <a16:creationId xmlns:a16="http://schemas.microsoft.com/office/drawing/2014/main" xmlns="" id="{29F51053-DA35-42B9-9AE2-BCF9F1B31ED1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68" t="10310"/>
          <a:stretch/>
        </p:blipFill>
        <p:spPr>
          <a:xfrm>
            <a:off x="8085735" y="2270736"/>
            <a:ext cx="3350290" cy="2889362"/>
          </a:xfrm>
          <a:prstGeom prst="rect">
            <a:avLst/>
          </a:prstGeom>
          <a:ln>
            <a:noFill/>
          </a:ln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xmlns="" id="{22DCBAA3-9BA6-421B-9DA3-3F8BF9F3CC5D}"/>
              </a:ext>
            </a:extLst>
          </p:cNvPr>
          <p:cNvSpPr txBox="1"/>
          <p:nvPr/>
        </p:nvSpPr>
        <p:spPr>
          <a:xfrm>
            <a:off x="2043213" y="1938589"/>
            <a:ext cx="15648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GSS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D79390B7-554F-4664-BC5C-C73267EAA7C0}"/>
              </a:ext>
            </a:extLst>
          </p:cNvPr>
          <p:cNvSpPr txBox="1"/>
          <p:nvPr/>
        </p:nvSpPr>
        <p:spPr>
          <a:xfrm>
            <a:off x="5472116" y="1895169"/>
            <a:ext cx="15648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MRI1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xmlns="" id="{29CCFD4C-C266-46FC-BB40-779F0AA66AF4}"/>
              </a:ext>
            </a:extLst>
          </p:cNvPr>
          <p:cNvSpPr txBox="1"/>
          <p:nvPr/>
        </p:nvSpPr>
        <p:spPr>
          <a:xfrm>
            <a:off x="9004226" y="1938590"/>
            <a:ext cx="156488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PLIN2*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C0BD01FC-ED8E-8626-0174-6150F87BF09A}"/>
              </a:ext>
            </a:extLst>
          </p:cNvPr>
          <p:cNvSpPr txBox="1"/>
          <p:nvPr/>
        </p:nvSpPr>
        <p:spPr>
          <a:xfrm>
            <a:off x="9391865" y="6581001"/>
            <a:ext cx="280013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Penick et al., Supplemental Figure 2</a:t>
            </a:r>
          </a:p>
        </p:txBody>
      </p:sp>
    </p:spTree>
    <p:extLst>
      <p:ext uri="{BB962C8B-B14F-4D97-AF65-F5344CB8AC3E}">
        <p14:creationId xmlns:p14="http://schemas.microsoft.com/office/powerpoint/2010/main" val="19946514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489</TotalTime>
  <Words>64</Words>
  <Application>Microsoft Office PowerPoint</Application>
  <PresentationFormat>Widescreen</PresentationFormat>
  <Paragraphs>1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cholas Bateman</dc:creator>
  <cp:lastModifiedBy>Ishwarya P.S.</cp:lastModifiedBy>
  <cp:revision>57</cp:revision>
  <dcterms:created xsi:type="dcterms:W3CDTF">2020-07-05T12:41:24Z</dcterms:created>
  <dcterms:modified xsi:type="dcterms:W3CDTF">2022-09-22T02:25:56Z</dcterms:modified>
</cp:coreProperties>
</file>